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S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732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caprisa-my.sharepoint.com/personal/santhana_gengiah_caprisa_org/Documents/SUPPLEMENTARY%20WORK%20FOR%20HIV-TB%20INDICATOR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caprisa-my.sharepoint.com/personal/santhana_gengiah_caprisa_org/Documents/SUPPLEMENTARY%20WORK%20FOR%20HIV-TB%20INDICATOR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caprisa-my.sharepoint.com/personal/santhana_gengiah_caprisa_org/Documents/SUPPLEMENTARY%20WORK%20FOR%20HIV-TB%20INDICATOR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caprisa-my.sharepoint.com/personal/santhana_gengiah_caprisa_org/Documents/SUPPLEMENTARY%20WORK%20FOR%20HIV-TB%20INDICATOR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caprisa-my.sharepoint.com/personal/santhana_gengiah_caprisa_org/Documents/SUPPLEMENTARY%20WORK%20FOR%20HIV-TB%20INDICATOR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caprisa-my.sharepoint.com/personal/santhana_gengiah_caprisa_org/Documents/SUPPLEMENTARY%20WORK%20FOR%20HIV-TB%20INDICATOR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HIV Testing Services </a:t>
            </a:r>
          </a:p>
        </c:rich>
      </c:tx>
      <c:layout>
        <c:manualLayout>
          <c:xMode val="edge"/>
          <c:yMode val="edge"/>
          <c:x val="0.26299345853143991"/>
          <c:y val="3.300072668172122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dk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SX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B$4</c:f>
              <c:strCache>
                <c:ptCount val="1"/>
                <c:pt idx="0">
                  <c:v>Baselin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GRAPHS!$C$3:$E$3</c:f>
              <c:strCache>
                <c:ptCount val="3"/>
                <c:pt idx="0">
                  <c:v>QI Arm </c:v>
                </c:pt>
                <c:pt idx="2">
                  <c:v>SOC Arm </c:v>
                </c:pt>
              </c:strCache>
            </c:strRef>
          </c:cat>
          <c:val>
            <c:numRef>
              <c:f>GRAPHS!$C$4:$E$4</c:f>
              <c:numCache>
                <c:formatCode>General</c:formatCode>
                <c:ptCount val="3"/>
                <c:pt idx="0" formatCode="0.00">
                  <c:v>84.8</c:v>
                </c:pt>
                <c:pt idx="1">
                  <c:v>0</c:v>
                </c:pt>
                <c:pt idx="2" formatCode="0.00">
                  <c:v>85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FC8-4FD2-A964-78AA86FD00EA}"/>
            </c:ext>
          </c:extLst>
        </c:ser>
        <c:ser>
          <c:idx val="1"/>
          <c:order val="1"/>
          <c:tx>
            <c:strRef>
              <c:f>GRAPHS!$B$5</c:f>
              <c:strCache>
                <c:ptCount val="1"/>
                <c:pt idx="0">
                  <c:v>Post QI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GRAPHS!$C$3:$E$3</c:f>
              <c:strCache>
                <c:ptCount val="3"/>
                <c:pt idx="0">
                  <c:v>QI Arm </c:v>
                </c:pt>
                <c:pt idx="2">
                  <c:v>SOC Arm </c:v>
                </c:pt>
              </c:strCache>
            </c:strRef>
          </c:cat>
          <c:val>
            <c:numRef>
              <c:f>GRAPHS!$C$5:$E$5</c:f>
              <c:numCache>
                <c:formatCode>General</c:formatCode>
                <c:ptCount val="3"/>
                <c:pt idx="0" formatCode="0.00">
                  <c:v>94.5</c:v>
                </c:pt>
                <c:pt idx="1">
                  <c:v>0</c:v>
                </c:pt>
                <c:pt idx="2" formatCode="0.00">
                  <c:v>88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FC8-4FD2-A964-78AA86FD00EA}"/>
            </c:ext>
          </c:extLst>
        </c:ser>
        <c:ser>
          <c:idx val="2"/>
          <c:order val="2"/>
          <c:tx>
            <c:strRef>
              <c:f>GRAPHS!$B$6</c:f>
              <c:strCache>
                <c:ptCount val="1"/>
                <c:pt idx="0">
                  <c:v>Improvement 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GRAPHS!$C$3:$E$3</c:f>
              <c:strCache>
                <c:ptCount val="3"/>
                <c:pt idx="0">
                  <c:v>QI Arm </c:v>
                </c:pt>
                <c:pt idx="2">
                  <c:v>SOC Arm </c:v>
                </c:pt>
              </c:strCache>
            </c:strRef>
          </c:cat>
          <c:val>
            <c:numRef>
              <c:f>GRAPHS!$C$6:$E$6</c:f>
              <c:numCache>
                <c:formatCode>General</c:formatCode>
                <c:ptCount val="3"/>
                <c:pt idx="0" formatCode="0.00">
                  <c:v>9.7000000000000028</c:v>
                </c:pt>
                <c:pt idx="1">
                  <c:v>0</c:v>
                </c:pt>
                <c:pt idx="2" formatCode="0.00">
                  <c:v>2.90000000000000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FC8-4FD2-A964-78AA86FD00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93311023"/>
        <c:axId val="1493312271"/>
      </c:barChart>
      <c:catAx>
        <c:axId val="149331102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  <c:crossAx val="1493312271"/>
        <c:crosses val="autoZero"/>
        <c:auto val="1"/>
        <c:lblAlgn val="ctr"/>
        <c:lblOffset val="100"/>
        <c:noMultiLvlLbl val="0"/>
      </c:catAx>
      <c:valAx>
        <c:axId val="1493312271"/>
        <c:scaling>
          <c:orientation val="minMax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  <c:crossAx val="1493311023"/>
        <c:crosses val="autoZero"/>
        <c:crossBetween val="between"/>
        <c:majorUnit val="20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</c:dTable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lt1"/>
    </a:solidFill>
    <a:ln w="12700" cap="flat" cmpd="sng" algn="ctr">
      <a:solidFill>
        <a:schemeClr val="dk1"/>
      </a:solidFill>
      <a:prstDash val="solid"/>
      <a:miter lim="800000"/>
    </a:ln>
    <a:effectLst/>
  </c:spPr>
  <c:txPr>
    <a:bodyPr/>
    <a:lstStyle/>
    <a:p>
      <a:pPr>
        <a:defRPr sz="1100">
          <a:solidFill>
            <a:schemeClr val="dk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pPr>
      <a:endParaRPr lang="en-SX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ZA"/>
              <a:t>HIV Testing Services in TB Patients </a:t>
            </a:r>
          </a:p>
        </c:rich>
      </c:tx>
      <c:layout>
        <c:manualLayout>
          <c:xMode val="edge"/>
          <c:yMode val="edge"/>
          <c:x val="0.12033644859813082"/>
          <c:y val="9.9235030747231966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dk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SX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B$11</c:f>
              <c:strCache>
                <c:ptCount val="1"/>
                <c:pt idx="0">
                  <c:v>Baselin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GRAPHS!$C$9:$E$10</c:f>
              <c:strCache>
                <c:ptCount val="3"/>
                <c:pt idx="0">
                  <c:v>QI Arm </c:v>
                </c:pt>
                <c:pt idx="2">
                  <c:v>SOC Arm </c:v>
                </c:pt>
              </c:strCache>
            </c:strRef>
          </c:cat>
          <c:val>
            <c:numRef>
              <c:f>GRAPHS!$C$11:$E$11</c:f>
              <c:numCache>
                <c:formatCode>General</c:formatCode>
                <c:ptCount val="3"/>
                <c:pt idx="0">
                  <c:v>88.7</c:v>
                </c:pt>
                <c:pt idx="1">
                  <c:v>0</c:v>
                </c:pt>
                <c:pt idx="2">
                  <c:v>85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02C-48CE-B5CC-F384FA12817B}"/>
            </c:ext>
          </c:extLst>
        </c:ser>
        <c:ser>
          <c:idx val="1"/>
          <c:order val="1"/>
          <c:tx>
            <c:strRef>
              <c:f>GRAPHS!$B$12</c:f>
              <c:strCache>
                <c:ptCount val="1"/>
                <c:pt idx="0">
                  <c:v>Post QI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GRAPHS!$C$9:$E$10</c:f>
              <c:strCache>
                <c:ptCount val="3"/>
                <c:pt idx="0">
                  <c:v>QI Arm </c:v>
                </c:pt>
                <c:pt idx="2">
                  <c:v>SOC Arm </c:v>
                </c:pt>
              </c:strCache>
            </c:strRef>
          </c:cat>
          <c:val>
            <c:numRef>
              <c:f>GRAPHS!$C$12:$E$12</c:f>
              <c:numCache>
                <c:formatCode>General</c:formatCode>
                <c:ptCount val="3"/>
                <c:pt idx="0">
                  <c:v>96.3</c:v>
                </c:pt>
                <c:pt idx="1">
                  <c:v>0</c:v>
                </c:pt>
                <c:pt idx="2">
                  <c:v>94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02C-48CE-B5CC-F384FA12817B}"/>
            </c:ext>
          </c:extLst>
        </c:ser>
        <c:ser>
          <c:idx val="2"/>
          <c:order val="2"/>
          <c:tx>
            <c:strRef>
              <c:f>GRAPHS!$B$13</c:f>
              <c:strCache>
                <c:ptCount val="1"/>
                <c:pt idx="0">
                  <c:v>Improvement 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GRAPHS!$C$9:$E$10</c:f>
              <c:strCache>
                <c:ptCount val="3"/>
                <c:pt idx="0">
                  <c:v>QI Arm </c:v>
                </c:pt>
                <c:pt idx="2">
                  <c:v>SOC Arm </c:v>
                </c:pt>
              </c:strCache>
            </c:strRef>
          </c:cat>
          <c:val>
            <c:numRef>
              <c:f>GRAPHS!$C$13:$E$13</c:f>
              <c:numCache>
                <c:formatCode>General</c:formatCode>
                <c:ptCount val="3"/>
                <c:pt idx="0">
                  <c:v>7.5999999999999943</c:v>
                </c:pt>
                <c:pt idx="2">
                  <c:v>9.20000000000000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02C-48CE-B5CC-F384FA1281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93306031"/>
        <c:axId val="1493311439"/>
      </c:barChart>
      <c:catAx>
        <c:axId val="149330603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  <c:crossAx val="1493311439"/>
        <c:crosses val="autoZero"/>
        <c:auto val="1"/>
        <c:lblAlgn val="ctr"/>
        <c:lblOffset val="100"/>
        <c:noMultiLvlLbl val="0"/>
      </c:catAx>
      <c:valAx>
        <c:axId val="1493311439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  <c:crossAx val="1493306031"/>
        <c:crosses val="autoZero"/>
        <c:crossBetween val="between"/>
        <c:majorUnit val="20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</c:dTable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lt1"/>
    </a:solidFill>
    <a:ln w="12700" cap="flat" cmpd="sng" algn="ctr">
      <a:solidFill>
        <a:schemeClr val="dk1"/>
      </a:solidFill>
      <a:prstDash val="solid"/>
      <a:miter lim="800000"/>
    </a:ln>
    <a:effectLst/>
  </c:spPr>
  <c:txPr>
    <a:bodyPr/>
    <a:lstStyle/>
    <a:p>
      <a:pPr>
        <a:defRPr sz="1100">
          <a:solidFill>
            <a:schemeClr val="dk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pPr>
      <a:endParaRPr lang="en-SX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ZA"/>
              <a:t>TB screening for PHC clinic attende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dk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SX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B$17</c:f>
              <c:strCache>
                <c:ptCount val="1"/>
                <c:pt idx="0">
                  <c:v>Baselin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GRAPHS!$C$15:$E$16</c:f>
              <c:strCache>
                <c:ptCount val="3"/>
                <c:pt idx="0">
                  <c:v>QI Arm</c:v>
                </c:pt>
                <c:pt idx="2">
                  <c:v>SOC Arm</c:v>
                </c:pt>
              </c:strCache>
            </c:strRef>
          </c:cat>
          <c:val>
            <c:numRef>
              <c:f>GRAPHS!$C$17:$E$17</c:f>
              <c:numCache>
                <c:formatCode>General</c:formatCode>
                <c:ptCount val="3"/>
                <c:pt idx="0">
                  <c:v>76.2</c:v>
                </c:pt>
                <c:pt idx="1">
                  <c:v>0</c:v>
                </c:pt>
                <c:pt idx="2">
                  <c:v>78.900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12D-4D6F-B289-A4333C0BC775}"/>
            </c:ext>
          </c:extLst>
        </c:ser>
        <c:ser>
          <c:idx val="1"/>
          <c:order val="1"/>
          <c:tx>
            <c:strRef>
              <c:f>GRAPHS!$B$18</c:f>
              <c:strCache>
                <c:ptCount val="1"/>
                <c:pt idx="0">
                  <c:v>Post QI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GRAPHS!$C$15:$E$16</c:f>
              <c:strCache>
                <c:ptCount val="3"/>
                <c:pt idx="0">
                  <c:v>QI Arm</c:v>
                </c:pt>
                <c:pt idx="2">
                  <c:v>SOC Arm</c:v>
                </c:pt>
              </c:strCache>
            </c:strRef>
          </c:cat>
          <c:val>
            <c:numRef>
              <c:f>GRAPHS!$C$18:$E$18</c:f>
              <c:numCache>
                <c:formatCode>General</c:formatCode>
                <c:ptCount val="3"/>
                <c:pt idx="0">
                  <c:v>85.2</c:v>
                </c:pt>
                <c:pt idx="1">
                  <c:v>0</c:v>
                </c:pt>
                <c:pt idx="2">
                  <c:v>86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12D-4D6F-B289-A4333C0BC775}"/>
            </c:ext>
          </c:extLst>
        </c:ser>
        <c:ser>
          <c:idx val="2"/>
          <c:order val="2"/>
          <c:tx>
            <c:strRef>
              <c:f>GRAPHS!$B$19</c:f>
              <c:strCache>
                <c:ptCount val="1"/>
                <c:pt idx="0">
                  <c:v>Improvement 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GRAPHS!$C$15:$E$16</c:f>
              <c:strCache>
                <c:ptCount val="3"/>
                <c:pt idx="0">
                  <c:v>QI Arm</c:v>
                </c:pt>
                <c:pt idx="2">
                  <c:v>SOC Arm</c:v>
                </c:pt>
              </c:strCache>
            </c:strRef>
          </c:cat>
          <c:val>
            <c:numRef>
              <c:f>GRAPHS!$C$19:$E$19</c:f>
              <c:numCache>
                <c:formatCode>General</c:formatCode>
                <c:ptCount val="3"/>
                <c:pt idx="0">
                  <c:v>9</c:v>
                </c:pt>
                <c:pt idx="2">
                  <c:v>7.69999999999998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12D-4D6F-B289-A4333C0BC7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6876463"/>
        <c:axId val="1686877295"/>
      </c:barChart>
      <c:catAx>
        <c:axId val="16868764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  <c:crossAx val="1686877295"/>
        <c:crosses val="autoZero"/>
        <c:auto val="1"/>
        <c:lblAlgn val="ctr"/>
        <c:lblOffset val="100"/>
        <c:noMultiLvlLbl val="0"/>
      </c:catAx>
      <c:valAx>
        <c:axId val="1686877295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  <c:crossAx val="1686876463"/>
        <c:crosses val="autoZero"/>
        <c:crossBetween val="between"/>
        <c:majorUnit val="20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</c:dTable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lt1"/>
    </a:solidFill>
    <a:ln w="12700" cap="flat" cmpd="sng" algn="ctr">
      <a:solidFill>
        <a:schemeClr val="dk1"/>
      </a:solidFill>
      <a:prstDash val="solid"/>
      <a:miter lim="800000"/>
    </a:ln>
    <a:effectLst/>
  </c:spPr>
  <c:txPr>
    <a:bodyPr/>
    <a:lstStyle/>
    <a:p>
      <a:pPr>
        <a:defRPr sz="1100">
          <a:solidFill>
            <a:schemeClr val="dk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pPr>
      <a:endParaRPr lang="en-SX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ZA"/>
              <a:t>ART initiation among HIV-TB patients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dk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SX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B$24</c:f>
              <c:strCache>
                <c:ptCount val="1"/>
                <c:pt idx="0">
                  <c:v>Baselin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GRAPHS!$C$22:$E$23</c:f>
              <c:strCache>
                <c:ptCount val="3"/>
                <c:pt idx="0">
                  <c:v>QI Arm</c:v>
                </c:pt>
                <c:pt idx="2">
                  <c:v>SOC Arm</c:v>
                </c:pt>
              </c:strCache>
            </c:strRef>
          </c:cat>
          <c:val>
            <c:numRef>
              <c:f>GRAPHS!$C$24:$E$24</c:f>
              <c:numCache>
                <c:formatCode>General</c:formatCode>
                <c:ptCount val="3"/>
                <c:pt idx="0">
                  <c:v>95.8</c:v>
                </c:pt>
                <c:pt idx="1">
                  <c:v>0</c:v>
                </c:pt>
                <c:pt idx="2">
                  <c:v>98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E99-4F93-AE41-192AC05D6E6A}"/>
            </c:ext>
          </c:extLst>
        </c:ser>
        <c:ser>
          <c:idx val="1"/>
          <c:order val="1"/>
          <c:tx>
            <c:strRef>
              <c:f>GRAPHS!$B$25</c:f>
              <c:strCache>
                <c:ptCount val="1"/>
                <c:pt idx="0">
                  <c:v>Post QI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GRAPHS!$C$22:$E$23</c:f>
              <c:strCache>
                <c:ptCount val="3"/>
                <c:pt idx="0">
                  <c:v>QI Arm</c:v>
                </c:pt>
                <c:pt idx="2">
                  <c:v>SOC Arm</c:v>
                </c:pt>
              </c:strCache>
            </c:strRef>
          </c:cat>
          <c:val>
            <c:numRef>
              <c:f>GRAPHS!$C$25:$E$25</c:f>
              <c:numCache>
                <c:formatCode>General</c:formatCode>
                <c:ptCount val="3"/>
                <c:pt idx="0">
                  <c:v>94.1</c:v>
                </c:pt>
                <c:pt idx="1">
                  <c:v>0</c:v>
                </c:pt>
                <c:pt idx="2">
                  <c:v>96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E99-4F93-AE41-192AC05D6E6A}"/>
            </c:ext>
          </c:extLst>
        </c:ser>
        <c:ser>
          <c:idx val="2"/>
          <c:order val="2"/>
          <c:tx>
            <c:strRef>
              <c:f>GRAPHS!$B$26</c:f>
              <c:strCache>
                <c:ptCount val="1"/>
                <c:pt idx="0">
                  <c:v>Improvement 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GRAPHS!$C$22:$E$23</c:f>
              <c:strCache>
                <c:ptCount val="3"/>
                <c:pt idx="0">
                  <c:v>QI Arm</c:v>
                </c:pt>
                <c:pt idx="2">
                  <c:v>SOC Arm</c:v>
                </c:pt>
              </c:strCache>
            </c:strRef>
          </c:cat>
          <c:val>
            <c:numRef>
              <c:f>GRAPHS!$C$26:$E$26</c:f>
              <c:numCache>
                <c:formatCode>General</c:formatCode>
                <c:ptCount val="3"/>
                <c:pt idx="0">
                  <c:v>-1.7000000000000028</c:v>
                </c:pt>
                <c:pt idx="1">
                  <c:v>0</c:v>
                </c:pt>
                <c:pt idx="2">
                  <c:v>-2.40000000000000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E99-4F93-AE41-192AC05D6E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78028911"/>
        <c:axId val="1678030575"/>
      </c:barChart>
      <c:catAx>
        <c:axId val="16780289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  <c:crossAx val="1678030575"/>
        <c:crosses val="autoZero"/>
        <c:auto val="1"/>
        <c:lblAlgn val="ctr"/>
        <c:lblOffset val="100"/>
        <c:noMultiLvlLbl val="0"/>
      </c:catAx>
      <c:valAx>
        <c:axId val="1678030575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  <c:crossAx val="1678028911"/>
        <c:crosses val="autoZero"/>
        <c:crossBetween val="between"/>
        <c:majorUnit val="20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</c:dTable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lt1"/>
    </a:solidFill>
    <a:ln w="12700" cap="flat" cmpd="sng" algn="ctr">
      <a:solidFill>
        <a:schemeClr val="dk1"/>
      </a:solidFill>
      <a:prstDash val="solid"/>
      <a:miter lim="800000"/>
    </a:ln>
    <a:effectLst/>
  </c:spPr>
  <c:txPr>
    <a:bodyPr/>
    <a:lstStyle/>
    <a:p>
      <a:pPr>
        <a:defRPr sz="1100">
          <a:solidFill>
            <a:schemeClr val="dk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pPr>
      <a:endParaRPr lang="en-SX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ZA" dirty="0"/>
              <a:t>Initiating IPT among eligible new ART patients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dk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SX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B$30</c:f>
              <c:strCache>
                <c:ptCount val="1"/>
                <c:pt idx="0">
                  <c:v>Baselin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GRAPHS!$C$28:$E$29</c:f>
              <c:strCache>
                <c:ptCount val="3"/>
                <c:pt idx="0">
                  <c:v>QI Arm </c:v>
                </c:pt>
                <c:pt idx="2">
                  <c:v>SOC Arm</c:v>
                </c:pt>
              </c:strCache>
            </c:strRef>
          </c:cat>
          <c:val>
            <c:numRef>
              <c:f>GRAPHS!$C$30:$E$30</c:f>
              <c:numCache>
                <c:formatCode>General</c:formatCode>
                <c:ptCount val="3"/>
                <c:pt idx="0">
                  <c:v>15.9</c:v>
                </c:pt>
                <c:pt idx="1">
                  <c:v>0</c:v>
                </c:pt>
                <c:pt idx="2">
                  <c:v>27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AF0-4A05-BD3E-AFBF44BBE038}"/>
            </c:ext>
          </c:extLst>
        </c:ser>
        <c:ser>
          <c:idx val="1"/>
          <c:order val="1"/>
          <c:tx>
            <c:strRef>
              <c:f>GRAPHS!$B$31</c:f>
              <c:strCache>
                <c:ptCount val="1"/>
                <c:pt idx="0">
                  <c:v>Post QI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GRAPHS!$C$28:$E$29</c:f>
              <c:strCache>
                <c:ptCount val="3"/>
                <c:pt idx="0">
                  <c:v>QI Arm </c:v>
                </c:pt>
                <c:pt idx="2">
                  <c:v>SOC Arm</c:v>
                </c:pt>
              </c:strCache>
            </c:strRef>
          </c:cat>
          <c:val>
            <c:numRef>
              <c:f>GRAPHS!$C$31:$E$31</c:f>
              <c:numCache>
                <c:formatCode>General</c:formatCode>
                <c:ptCount val="3"/>
                <c:pt idx="0">
                  <c:v>76.400000000000006</c:v>
                </c:pt>
                <c:pt idx="1">
                  <c:v>0</c:v>
                </c:pt>
                <c:pt idx="2">
                  <c:v>50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AF0-4A05-BD3E-AFBF44BBE038}"/>
            </c:ext>
          </c:extLst>
        </c:ser>
        <c:ser>
          <c:idx val="2"/>
          <c:order val="2"/>
          <c:tx>
            <c:strRef>
              <c:f>GRAPHS!$B$32</c:f>
              <c:strCache>
                <c:ptCount val="1"/>
                <c:pt idx="0">
                  <c:v>Improvement 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GRAPHS!$C$28:$E$29</c:f>
              <c:strCache>
                <c:ptCount val="3"/>
                <c:pt idx="0">
                  <c:v>QI Arm </c:v>
                </c:pt>
                <c:pt idx="2">
                  <c:v>SOC Arm</c:v>
                </c:pt>
              </c:strCache>
            </c:strRef>
          </c:cat>
          <c:val>
            <c:numRef>
              <c:f>GRAPHS!$C$32:$E$32</c:f>
              <c:numCache>
                <c:formatCode>General</c:formatCode>
                <c:ptCount val="3"/>
                <c:pt idx="0">
                  <c:v>60.500000000000007</c:v>
                </c:pt>
                <c:pt idx="1">
                  <c:v>0</c:v>
                </c:pt>
                <c:pt idx="2">
                  <c:v>23.0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AF0-4A05-BD3E-AFBF44BBE0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05163871"/>
        <c:axId val="1505165535"/>
      </c:barChart>
      <c:catAx>
        <c:axId val="15051638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  <c:crossAx val="1505165535"/>
        <c:crosses val="autoZero"/>
        <c:auto val="1"/>
        <c:lblAlgn val="ctr"/>
        <c:lblOffset val="100"/>
        <c:noMultiLvlLbl val="0"/>
      </c:catAx>
      <c:valAx>
        <c:axId val="1505165535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  <c:crossAx val="1505163871"/>
        <c:crosses val="autoZero"/>
        <c:crossBetween val="between"/>
        <c:majorUnit val="20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</c:dTable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lt1"/>
    </a:solidFill>
    <a:ln w="12700" cap="flat" cmpd="sng" algn="ctr">
      <a:solidFill>
        <a:schemeClr val="dk1"/>
      </a:solidFill>
      <a:prstDash val="solid"/>
      <a:miter lim="800000"/>
    </a:ln>
    <a:effectLst/>
  </c:spPr>
  <c:txPr>
    <a:bodyPr/>
    <a:lstStyle/>
    <a:p>
      <a:pPr>
        <a:defRPr sz="1100">
          <a:solidFill>
            <a:schemeClr val="dk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pPr>
      <a:endParaRPr lang="en-SX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ZA" sz="1320" b="0" i="0" u="none" strike="noStrike" kern="1200" spc="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ZA" sz="1320" b="0" i="0" u="none" strike="noStrike" kern="1200" spc="0" baseline="0" dirty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iral Load Testing at Month 12 after ART initiation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ZA" sz="1320" b="0" i="0" u="none" strike="noStrike" kern="1200" spc="0" baseline="0">
              <a:solidFill>
                <a:prstClr val="black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SX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B$36</c:f>
              <c:strCache>
                <c:ptCount val="1"/>
                <c:pt idx="0">
                  <c:v>Baselin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GRAPHS!$C$34:$E$35</c:f>
              <c:strCache>
                <c:ptCount val="3"/>
                <c:pt idx="0">
                  <c:v>QI Arm </c:v>
                </c:pt>
                <c:pt idx="2">
                  <c:v>SOC Arm</c:v>
                </c:pt>
              </c:strCache>
            </c:strRef>
          </c:cat>
          <c:val>
            <c:numRef>
              <c:f>GRAPHS!$C$36:$E$36</c:f>
              <c:numCache>
                <c:formatCode>General</c:formatCode>
                <c:ptCount val="3"/>
                <c:pt idx="0">
                  <c:v>61.4</c:v>
                </c:pt>
                <c:pt idx="1">
                  <c:v>0</c:v>
                </c:pt>
                <c:pt idx="2">
                  <c:v>57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195-4759-BF6D-D3A3320D2400}"/>
            </c:ext>
          </c:extLst>
        </c:ser>
        <c:ser>
          <c:idx val="1"/>
          <c:order val="1"/>
          <c:tx>
            <c:strRef>
              <c:f>GRAPHS!$B$37</c:f>
              <c:strCache>
                <c:ptCount val="1"/>
                <c:pt idx="0">
                  <c:v>Post QI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GRAPHS!$C$34:$E$35</c:f>
              <c:strCache>
                <c:ptCount val="3"/>
                <c:pt idx="0">
                  <c:v>QI Arm </c:v>
                </c:pt>
                <c:pt idx="2">
                  <c:v>SOC Arm</c:v>
                </c:pt>
              </c:strCache>
            </c:strRef>
          </c:cat>
          <c:val>
            <c:numRef>
              <c:f>GRAPHS!$C$37:$E$37</c:f>
              <c:numCache>
                <c:formatCode>General</c:formatCode>
                <c:ptCount val="3"/>
                <c:pt idx="0">
                  <c:v>72.2</c:v>
                </c:pt>
                <c:pt idx="1">
                  <c:v>0</c:v>
                </c:pt>
                <c:pt idx="2">
                  <c:v>72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195-4759-BF6D-D3A3320D2400}"/>
            </c:ext>
          </c:extLst>
        </c:ser>
        <c:ser>
          <c:idx val="2"/>
          <c:order val="2"/>
          <c:tx>
            <c:strRef>
              <c:f>GRAPHS!$B$38</c:f>
              <c:strCache>
                <c:ptCount val="1"/>
                <c:pt idx="0">
                  <c:v>Improvement 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GRAPHS!$C$34:$E$35</c:f>
              <c:strCache>
                <c:ptCount val="3"/>
                <c:pt idx="0">
                  <c:v>QI Arm </c:v>
                </c:pt>
                <c:pt idx="2">
                  <c:v>SOC Arm</c:v>
                </c:pt>
              </c:strCache>
            </c:strRef>
          </c:cat>
          <c:val>
            <c:numRef>
              <c:f>GRAPHS!$C$38:$E$38</c:f>
              <c:numCache>
                <c:formatCode>General</c:formatCode>
                <c:ptCount val="3"/>
                <c:pt idx="0">
                  <c:v>10.800000000000004</c:v>
                </c:pt>
                <c:pt idx="1">
                  <c:v>0</c:v>
                </c:pt>
                <c:pt idx="2">
                  <c:v>15.29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195-4759-BF6D-D3A3320D24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96933151"/>
        <c:axId val="1496931071"/>
      </c:barChart>
      <c:catAx>
        <c:axId val="149693315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  <c:crossAx val="1496931071"/>
        <c:crosses val="autoZero"/>
        <c:auto val="1"/>
        <c:lblAlgn val="ctr"/>
        <c:lblOffset val="100"/>
        <c:noMultiLvlLbl val="0"/>
      </c:catAx>
      <c:valAx>
        <c:axId val="1496931071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  <c:crossAx val="1496933151"/>
        <c:crosses val="autoZero"/>
        <c:crossBetween val="between"/>
        <c:majorUnit val="20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1100" b="0" i="0" u="none" strike="noStrike" kern="1200" baseline="0">
                <a:solidFill>
                  <a:schemeClr val="dk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SX"/>
          </a:p>
        </c:txPr>
      </c:dTable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lt1"/>
    </a:solidFill>
    <a:ln w="12700" cap="flat" cmpd="sng" algn="ctr">
      <a:solidFill>
        <a:schemeClr val="dk1"/>
      </a:solidFill>
      <a:prstDash val="solid"/>
      <a:miter lim="800000"/>
    </a:ln>
    <a:effectLst/>
  </c:spPr>
  <c:txPr>
    <a:bodyPr/>
    <a:lstStyle/>
    <a:p>
      <a:pPr>
        <a:defRPr sz="1100">
          <a:solidFill>
            <a:schemeClr val="dk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pPr>
      <a:endParaRPr lang="en-SX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8330BC-9739-4692-BD6B-7E0CF11696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SX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6850533-F829-4C82-AF33-FA08BE3FF4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SX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108F4A-C288-4D70-96E1-745F80FAA1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8E0BF-414B-4B36-BE0D-FC82A07A123C}" type="datetimeFigureOut">
              <a:rPr lang="en-SX" smtClean="0"/>
              <a:t>28/07/2021</a:t>
            </a:fld>
            <a:endParaRPr lang="en-S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1FAE04-17F6-47E9-99E3-46533B64F8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6F099A-B02C-4049-845A-F5AAB01D6C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0B74-C365-41C4-949C-A2472A28E4D3}" type="slidenum">
              <a:rPr lang="en-SX" smtClean="0"/>
              <a:t>‹#›</a:t>
            </a:fld>
            <a:endParaRPr lang="en-SX"/>
          </a:p>
        </p:txBody>
      </p:sp>
    </p:spTree>
    <p:extLst>
      <p:ext uri="{BB962C8B-B14F-4D97-AF65-F5344CB8AC3E}">
        <p14:creationId xmlns:p14="http://schemas.microsoft.com/office/powerpoint/2010/main" val="3394556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ABE571-DA0C-4B87-B7FE-9F508B42A3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X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D1B28C-BE6E-4EC9-A360-4A0EDA1FEA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X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EB82F4-C58C-4CB9-84E4-D35F4A6A47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8E0BF-414B-4B36-BE0D-FC82A07A123C}" type="datetimeFigureOut">
              <a:rPr lang="en-SX" smtClean="0"/>
              <a:t>28/07/2021</a:t>
            </a:fld>
            <a:endParaRPr lang="en-S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E5DAFA-7059-4FBA-86BA-DDBF3A9B3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A23E20-7D0D-4EC3-B7E5-478EB2CBF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0B74-C365-41C4-949C-A2472A28E4D3}" type="slidenum">
              <a:rPr lang="en-SX" smtClean="0"/>
              <a:t>‹#›</a:t>
            </a:fld>
            <a:endParaRPr lang="en-SX"/>
          </a:p>
        </p:txBody>
      </p:sp>
    </p:spTree>
    <p:extLst>
      <p:ext uri="{BB962C8B-B14F-4D97-AF65-F5344CB8AC3E}">
        <p14:creationId xmlns:p14="http://schemas.microsoft.com/office/powerpoint/2010/main" val="2450763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BC34E3C-8A0B-465C-A256-57A5987225D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SX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C35C50-AB35-446A-859F-372620B9A6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X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8541E4-F8E1-42A1-A6CC-8215AC0A9A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8E0BF-414B-4B36-BE0D-FC82A07A123C}" type="datetimeFigureOut">
              <a:rPr lang="en-SX" smtClean="0"/>
              <a:t>28/07/2021</a:t>
            </a:fld>
            <a:endParaRPr lang="en-S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ACB604-A864-40CB-B29B-9BF16B084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FE193E-8E08-41DB-8E43-0E7E734DB1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0B74-C365-41C4-949C-A2472A28E4D3}" type="slidenum">
              <a:rPr lang="en-SX" smtClean="0"/>
              <a:t>‹#›</a:t>
            </a:fld>
            <a:endParaRPr lang="en-SX"/>
          </a:p>
        </p:txBody>
      </p:sp>
    </p:spTree>
    <p:extLst>
      <p:ext uri="{BB962C8B-B14F-4D97-AF65-F5344CB8AC3E}">
        <p14:creationId xmlns:p14="http://schemas.microsoft.com/office/powerpoint/2010/main" val="597529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C532B0-CCF5-4104-8C30-1B05AEF5A2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X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785557-0836-41DC-9971-4E4E2F75C9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X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066E68-07D7-4E11-A1A9-C01E0BC99D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8E0BF-414B-4B36-BE0D-FC82A07A123C}" type="datetimeFigureOut">
              <a:rPr lang="en-SX" smtClean="0"/>
              <a:t>28/07/2021</a:t>
            </a:fld>
            <a:endParaRPr lang="en-S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D29A43-7AD3-48DF-BA53-22000430F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502D5C-EE0A-40D2-86F9-D9AE891FDF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0B74-C365-41C4-949C-A2472A28E4D3}" type="slidenum">
              <a:rPr lang="en-SX" smtClean="0"/>
              <a:t>‹#›</a:t>
            </a:fld>
            <a:endParaRPr lang="en-SX"/>
          </a:p>
        </p:txBody>
      </p:sp>
    </p:spTree>
    <p:extLst>
      <p:ext uri="{BB962C8B-B14F-4D97-AF65-F5344CB8AC3E}">
        <p14:creationId xmlns:p14="http://schemas.microsoft.com/office/powerpoint/2010/main" val="2165605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1A52FB-819D-4E90-9B19-8912AFE53F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SX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ACB493-7E94-4CB3-B4BD-9BD98D5FEA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77F04A-6858-4B2C-BC2D-6BEB1CBA1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8E0BF-414B-4B36-BE0D-FC82A07A123C}" type="datetimeFigureOut">
              <a:rPr lang="en-SX" smtClean="0"/>
              <a:t>28/07/2021</a:t>
            </a:fld>
            <a:endParaRPr lang="en-S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35A3BC-82AD-47F1-A912-1EE3370A77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5A2657-3310-4112-B0A2-CEE81DC1A9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0B74-C365-41C4-949C-A2472A28E4D3}" type="slidenum">
              <a:rPr lang="en-SX" smtClean="0"/>
              <a:t>‹#›</a:t>
            </a:fld>
            <a:endParaRPr lang="en-SX"/>
          </a:p>
        </p:txBody>
      </p:sp>
    </p:spTree>
    <p:extLst>
      <p:ext uri="{BB962C8B-B14F-4D97-AF65-F5344CB8AC3E}">
        <p14:creationId xmlns:p14="http://schemas.microsoft.com/office/powerpoint/2010/main" val="22567168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CEFC94-2163-40F8-8051-1A6B401991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X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B8F5FD-CB3D-45C9-896C-11007D02D7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X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6FFA10-18C8-4C3F-BDA8-7904D56D46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X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56C0CF-5A7F-4B68-AC0C-519A451BA3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8E0BF-414B-4B36-BE0D-FC82A07A123C}" type="datetimeFigureOut">
              <a:rPr lang="en-SX" smtClean="0"/>
              <a:t>28/07/2021</a:t>
            </a:fld>
            <a:endParaRPr lang="en-SX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4B6EA3-8E1D-4F26-AF68-03CAE3652E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X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A7A105-7293-4A6E-8465-BC45865DF1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0B74-C365-41C4-949C-A2472A28E4D3}" type="slidenum">
              <a:rPr lang="en-SX" smtClean="0"/>
              <a:t>‹#›</a:t>
            </a:fld>
            <a:endParaRPr lang="en-SX"/>
          </a:p>
        </p:txBody>
      </p:sp>
    </p:spTree>
    <p:extLst>
      <p:ext uri="{BB962C8B-B14F-4D97-AF65-F5344CB8AC3E}">
        <p14:creationId xmlns:p14="http://schemas.microsoft.com/office/powerpoint/2010/main" val="1196974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D01CDC-B445-4295-8C91-A62B00FDCD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SX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272A38-E33D-4D79-8A1C-2E9B270750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B588C2-8A5F-479B-8EF4-D81484299B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X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9976E76-4FA9-40A4-AC61-FD5665AEB4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B6BCFB4-8271-461C-B1A0-44303B46C12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X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5633E4-159F-4112-956A-B9D388693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8E0BF-414B-4B36-BE0D-FC82A07A123C}" type="datetimeFigureOut">
              <a:rPr lang="en-SX" smtClean="0"/>
              <a:t>28/07/2021</a:t>
            </a:fld>
            <a:endParaRPr lang="en-SX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4DE3BAF-4E9D-467C-A84F-68FC35EC4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X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D3D68E9-6C07-4B9E-A8E7-D6FC9DAA4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0B74-C365-41C4-949C-A2472A28E4D3}" type="slidenum">
              <a:rPr lang="en-SX" smtClean="0"/>
              <a:t>‹#›</a:t>
            </a:fld>
            <a:endParaRPr lang="en-SX"/>
          </a:p>
        </p:txBody>
      </p:sp>
    </p:spTree>
    <p:extLst>
      <p:ext uri="{BB962C8B-B14F-4D97-AF65-F5344CB8AC3E}">
        <p14:creationId xmlns:p14="http://schemas.microsoft.com/office/powerpoint/2010/main" val="98717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45C615-DED5-40F9-9AAB-3D62D9C38E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X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0B167D-1C46-4A48-9981-8249178E2C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8E0BF-414B-4B36-BE0D-FC82A07A123C}" type="datetimeFigureOut">
              <a:rPr lang="en-SX" smtClean="0"/>
              <a:t>28/07/2021</a:t>
            </a:fld>
            <a:endParaRPr lang="en-SX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0762087-F6EF-441F-98CA-B8542998A2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X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CB5EBDE-1E84-4A6C-8F3D-0F52B42F13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0B74-C365-41C4-949C-A2472A28E4D3}" type="slidenum">
              <a:rPr lang="en-SX" smtClean="0"/>
              <a:t>‹#›</a:t>
            </a:fld>
            <a:endParaRPr lang="en-SX"/>
          </a:p>
        </p:txBody>
      </p:sp>
    </p:spTree>
    <p:extLst>
      <p:ext uri="{BB962C8B-B14F-4D97-AF65-F5344CB8AC3E}">
        <p14:creationId xmlns:p14="http://schemas.microsoft.com/office/powerpoint/2010/main" val="397640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1D1FC5-E6A2-4A89-8DD1-7790E135C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8E0BF-414B-4B36-BE0D-FC82A07A123C}" type="datetimeFigureOut">
              <a:rPr lang="en-SX" smtClean="0"/>
              <a:t>28/07/2021</a:t>
            </a:fld>
            <a:endParaRPr lang="en-SX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B3DAC01-FAE7-4C5E-8626-3202BB8E2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X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1A970E8-AB92-4E82-9BDD-C325AA74F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0B74-C365-41C4-949C-A2472A28E4D3}" type="slidenum">
              <a:rPr lang="en-SX" smtClean="0"/>
              <a:t>‹#›</a:t>
            </a:fld>
            <a:endParaRPr lang="en-SX"/>
          </a:p>
        </p:txBody>
      </p:sp>
    </p:spTree>
    <p:extLst>
      <p:ext uri="{BB962C8B-B14F-4D97-AF65-F5344CB8AC3E}">
        <p14:creationId xmlns:p14="http://schemas.microsoft.com/office/powerpoint/2010/main" val="1061138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A4B07F-B5CF-4040-A64C-30D393A738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X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6D9488-DD2D-4BB5-A78C-173B9CDA03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X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12A3B3-0435-4815-BD56-3716EA08E2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9A342B-D549-4F79-98B4-A7A4986CC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8E0BF-414B-4B36-BE0D-FC82A07A123C}" type="datetimeFigureOut">
              <a:rPr lang="en-SX" smtClean="0"/>
              <a:t>28/07/2021</a:t>
            </a:fld>
            <a:endParaRPr lang="en-SX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8EE7EF-14A0-426E-85BE-335B767F5F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X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68080E-58FA-481F-8D6C-8C8C9AC163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0B74-C365-41C4-949C-A2472A28E4D3}" type="slidenum">
              <a:rPr lang="en-SX" smtClean="0"/>
              <a:t>‹#›</a:t>
            </a:fld>
            <a:endParaRPr lang="en-SX"/>
          </a:p>
        </p:txBody>
      </p:sp>
    </p:spTree>
    <p:extLst>
      <p:ext uri="{BB962C8B-B14F-4D97-AF65-F5344CB8AC3E}">
        <p14:creationId xmlns:p14="http://schemas.microsoft.com/office/powerpoint/2010/main" val="16510764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666E39-21F2-4E91-A00D-FAFA9CFC09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X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AA0E4B-63C7-40CC-BDDB-42430C3917B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X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15D3EB-0321-418B-A3AA-62B6A6DF9D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4CF9C9-5B3E-4726-840F-2ABE7A8AF1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8E0BF-414B-4B36-BE0D-FC82A07A123C}" type="datetimeFigureOut">
              <a:rPr lang="en-SX" smtClean="0"/>
              <a:t>28/07/2021</a:t>
            </a:fld>
            <a:endParaRPr lang="en-SX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AC86E9-5BC4-413D-8461-929DAFD673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X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A07FB0-F1A3-4BE9-B429-00BA0B5F05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10B74-C365-41C4-949C-A2472A28E4D3}" type="slidenum">
              <a:rPr lang="en-SX" smtClean="0"/>
              <a:t>‹#›</a:t>
            </a:fld>
            <a:endParaRPr lang="en-SX"/>
          </a:p>
        </p:txBody>
      </p:sp>
    </p:spTree>
    <p:extLst>
      <p:ext uri="{BB962C8B-B14F-4D97-AF65-F5344CB8AC3E}">
        <p14:creationId xmlns:p14="http://schemas.microsoft.com/office/powerpoint/2010/main" val="3950350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E681D67-BCF5-49BB-847C-2786EEDB04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SX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7404A4-5D59-4996-8129-C4BB6B4DA1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X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10BF30-B0EB-4225-89C3-334F6A0BDA0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C8E0BF-414B-4B36-BE0D-FC82A07A123C}" type="datetimeFigureOut">
              <a:rPr lang="en-SX" smtClean="0"/>
              <a:t>28/07/2021</a:t>
            </a:fld>
            <a:endParaRPr lang="en-SX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16B569-0EC4-45C2-813E-0A70BCCF7E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X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3061C1-3C0D-4314-8F88-DBD633B5B27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210B74-C365-41C4-949C-A2472A28E4D3}" type="slidenum">
              <a:rPr lang="en-SX" smtClean="0"/>
              <a:t>‹#›</a:t>
            </a:fld>
            <a:endParaRPr lang="en-SX"/>
          </a:p>
        </p:txBody>
      </p:sp>
    </p:spTree>
    <p:extLst>
      <p:ext uri="{BB962C8B-B14F-4D97-AF65-F5344CB8AC3E}">
        <p14:creationId xmlns:p14="http://schemas.microsoft.com/office/powerpoint/2010/main" val="2921581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DAEA996B-25CD-4B6F-8738-77139F7746A4}"/>
              </a:ext>
            </a:extLst>
          </p:cNvPr>
          <p:cNvGraphicFramePr>
            <a:graphicFrameLocks/>
          </p:cNvGraphicFramePr>
          <p:nvPr/>
        </p:nvGraphicFramePr>
        <p:xfrm>
          <a:off x="373869" y="280668"/>
          <a:ext cx="3383491" cy="25595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56FAE068-92FF-42DD-9856-E667ADE98E9B}"/>
              </a:ext>
            </a:extLst>
          </p:cNvPr>
          <p:cNvGraphicFramePr>
            <a:graphicFrameLocks/>
          </p:cNvGraphicFramePr>
          <p:nvPr/>
        </p:nvGraphicFramePr>
        <p:xfrm>
          <a:off x="4197602" y="290319"/>
          <a:ext cx="3397250" cy="25595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20F7497B-61C8-49FB-8265-4C9D30D8C0AF}"/>
              </a:ext>
            </a:extLst>
          </p:cNvPr>
          <p:cNvGraphicFramePr>
            <a:graphicFrameLocks/>
          </p:cNvGraphicFramePr>
          <p:nvPr/>
        </p:nvGraphicFramePr>
        <p:xfrm>
          <a:off x="8072273" y="280667"/>
          <a:ext cx="3397250" cy="25692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C429380C-2211-4F89-B5E7-778D24EE922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1473440"/>
              </p:ext>
            </p:extLst>
          </p:nvPr>
        </p:nvGraphicFramePr>
        <p:xfrm>
          <a:off x="4288647" y="3511888"/>
          <a:ext cx="3323166" cy="25595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9AF7275D-B848-4357-9E02-776E47FA894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0671917"/>
              </p:ext>
            </p:extLst>
          </p:nvPr>
        </p:nvGraphicFramePr>
        <p:xfrm>
          <a:off x="447953" y="3507424"/>
          <a:ext cx="3323166" cy="25595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FD114825-C9A7-451E-B79D-0F846D7305D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89234149"/>
              </p:ext>
            </p:extLst>
          </p:nvPr>
        </p:nvGraphicFramePr>
        <p:xfrm>
          <a:off x="8072273" y="3507424"/>
          <a:ext cx="3323166" cy="25794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E6D85A92-2232-4A0D-87C6-6544DEA0D97B}"/>
              </a:ext>
            </a:extLst>
          </p:cNvPr>
          <p:cNvSpPr txBox="1"/>
          <p:nvPr/>
        </p:nvSpPr>
        <p:spPr>
          <a:xfrm>
            <a:off x="336827" y="6438832"/>
            <a:ext cx="97317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Performance in integrated HIV-TB service delivery in Quality Improvement  and Standard of Care arms</a:t>
            </a:r>
            <a:endParaRPr lang="en-S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441CCC4-BEBA-4A7E-A460-86CE616F309F}"/>
              </a:ext>
            </a:extLst>
          </p:cNvPr>
          <p:cNvSpPr txBox="1"/>
          <p:nvPr/>
        </p:nvSpPr>
        <p:spPr>
          <a:xfrm>
            <a:off x="373869" y="2849899"/>
            <a:ext cx="33972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1A: HIV Testing Services  in the QI and SOC arms</a:t>
            </a:r>
            <a:endParaRPr lang="en-SX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51E41A8-01AF-4406-9528-466DF47B2C2E}"/>
              </a:ext>
            </a:extLst>
          </p:cNvPr>
          <p:cNvSpPr txBox="1"/>
          <p:nvPr/>
        </p:nvSpPr>
        <p:spPr>
          <a:xfrm>
            <a:off x="4197602" y="2849899"/>
            <a:ext cx="33972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1B: HIV Testing rates in TB patients </a:t>
            </a:r>
            <a:endParaRPr lang="en-SX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13DF484-12A8-4CC8-BFF8-5A3B13CFF041}"/>
              </a:ext>
            </a:extLst>
          </p:cNvPr>
          <p:cNvSpPr txBox="1"/>
          <p:nvPr/>
        </p:nvSpPr>
        <p:spPr>
          <a:xfrm>
            <a:off x="8092299" y="2840248"/>
            <a:ext cx="33972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1C : TB screening rates among PHC clinic </a:t>
            </a:r>
            <a:endParaRPr lang="en-SX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9D48575-0AC2-49DE-ACA4-889D088C42D8}"/>
              </a:ext>
            </a:extLst>
          </p:cNvPr>
          <p:cNvSpPr txBox="1"/>
          <p:nvPr/>
        </p:nvSpPr>
        <p:spPr>
          <a:xfrm>
            <a:off x="336827" y="6053387"/>
            <a:ext cx="33972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1D: IPT initiation rates among new ART patients </a:t>
            </a:r>
            <a:endParaRPr lang="en-SX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E378E0F-1AC1-4999-86D9-BCD64482830C}"/>
              </a:ext>
            </a:extLst>
          </p:cNvPr>
          <p:cNvSpPr txBox="1"/>
          <p:nvPr/>
        </p:nvSpPr>
        <p:spPr>
          <a:xfrm>
            <a:off x="4251605" y="6069500"/>
            <a:ext cx="33972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1 E:ART initiation rates among HIV-TB co-infected patients </a:t>
            </a:r>
            <a:endParaRPr lang="en-SX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A4EFBB7-CC96-4F09-955B-3E7CB91275CE}"/>
              </a:ext>
            </a:extLst>
          </p:cNvPr>
          <p:cNvSpPr txBox="1"/>
          <p:nvPr/>
        </p:nvSpPr>
        <p:spPr>
          <a:xfrm>
            <a:off x="8072273" y="6069500"/>
            <a:ext cx="33972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1F: Viral load testing rates among patients at Month 12 on ART</a:t>
            </a:r>
            <a:endParaRPr lang="en-SX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5505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6</TotalTime>
  <Words>119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thana Gengiah</dc:creator>
  <cp:lastModifiedBy>Santhana Gengiah</cp:lastModifiedBy>
  <cp:revision>4</cp:revision>
  <dcterms:created xsi:type="dcterms:W3CDTF">2021-07-13T19:44:54Z</dcterms:created>
  <dcterms:modified xsi:type="dcterms:W3CDTF">2021-07-28T18:37:49Z</dcterms:modified>
</cp:coreProperties>
</file>